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0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8/09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8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67544" y="5384205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rimble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553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w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Mechanisms involved in beta cell stress and immune dysfunction in chronic intergenerational undernutrition, showing effects on type 1 diabetes with altered autoantibody profile (T1D*) and autoantibody-negative insulin-dependent diabetes (Ab-</a:t>
            </a:r>
            <a:r>
              <a:rPr lang="en-GB" sz="1600" dirty="0" err="1"/>
              <a:t>ve</a:t>
            </a:r>
            <a:r>
              <a:rPr lang="en-GB" sz="1600" dirty="0"/>
              <a:t> IDD)</a:t>
            </a:r>
            <a:endParaRPr lang="en-GB" sz="16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D5F2791-FB84-8D0A-C4D2-56D0E71129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3852" y="1316797"/>
            <a:ext cx="7236296" cy="4224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7</cp:revision>
  <dcterms:created xsi:type="dcterms:W3CDTF">2016-06-15T12:53:43Z</dcterms:created>
  <dcterms:modified xsi:type="dcterms:W3CDTF">2025-09-18T11:13:58Z</dcterms:modified>
</cp:coreProperties>
</file>